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BC104B-1A6D-47B8-A792-CD8C10F9C8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CB2B73-F6D2-4C41-A67A-9E78BA187C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1D2FD2-E04C-40EF-B207-1700E2817C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67D02E-1010-47A3-A4FF-8672657E9B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CF7B58-5BB3-498F-83BD-D9A5C2255F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F9A464-969F-4BEA-A2E5-5AAC0A8680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EFA516-42E8-4557-B886-E00476E012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46428B-1FFB-4DFD-8774-8DDEFED742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882C5E-DB4D-4903-88A0-B51B021C6E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08BF3B-70F9-4282-ABB7-390C316A72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C39FAA-C98A-4E88-9976-9BA9206DF0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A2059-E8BE-4649-8ED3-CD4989AD3D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CCDC84-8F30-4ACB-9E67-8EFA1F053EB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2447" r="0" b="0"/>
          <a:stretch/>
        </p:blipFill>
        <p:spPr>
          <a:xfrm>
            <a:off x="857160" y="304920"/>
            <a:ext cx="5419800" cy="45543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24000" y="5676840"/>
            <a:ext cx="628776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Supplementary figure 1.</a:t>
            </a: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 The amygdala peptidome wa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njected to an Ettan LC system with a high pH stable X-Terra RP18 column (C18; 1 x 150mm; 3.5μm) (Waters) at  a flow rate of 40 </a:t>
            </a: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l/min. The peptides were eluted with a mobile phase B of 5–65% linear gradient over 35 min (A, 5 mM ABC in water at pH 9.8; B, 5 mM ABC in acetonitrile at pH 9.8). Twenty fractions were collected (one every 2 min). The chromatogram obtained is shown (blue line represents the absorbance at 215nm).</a:t>
            </a: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976480" y="5067360"/>
            <a:ext cx="108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20 Fractio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6200000">
            <a:off x="-287280" y="2214360"/>
            <a:ext cx="187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Intensity (mAU, 215n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127840" y="4259160"/>
            <a:ext cx="90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time (mi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228760" y="4991040"/>
            <a:ext cx="2971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flipV="1">
            <a:off x="2228760" y="483840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flipV="1">
            <a:off x="5200560" y="483840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"/>
          <p:cNvGrpSpPr/>
          <p:nvPr/>
        </p:nvGrpSpPr>
        <p:grpSpPr>
          <a:xfrm>
            <a:off x="146160" y="57240"/>
            <a:ext cx="6583320" cy="8773920"/>
            <a:chOff x="146160" y="57240"/>
            <a:chExt cx="6583320" cy="8773920"/>
          </a:xfrm>
        </p:grpSpPr>
        <p:grpSp>
          <p:nvGrpSpPr>
            <p:cNvPr id="50" name=""/>
            <p:cNvGrpSpPr/>
            <p:nvPr/>
          </p:nvGrpSpPr>
          <p:grpSpPr>
            <a:xfrm>
              <a:off x="158760" y="57240"/>
              <a:ext cx="6570720" cy="8229600"/>
              <a:chOff x="158760" y="57240"/>
              <a:chExt cx="6570720" cy="8229600"/>
            </a:xfrm>
          </p:grpSpPr>
          <p:pic>
            <p:nvPicPr>
              <p:cNvPr id="51" name="" descr=""/>
              <p:cNvPicPr/>
              <p:nvPr/>
            </p:nvPicPr>
            <p:blipFill>
              <a:blip r:embed="rId1"/>
              <a:srcRect l="7896" t="1448" r="3768" b="1448"/>
              <a:stretch/>
            </p:blipFill>
            <p:spPr>
              <a:xfrm>
                <a:off x="158760" y="57240"/>
                <a:ext cx="6570720" cy="8229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" name=""/>
              <p:cNvSpPr/>
              <p:nvPr/>
            </p:nvSpPr>
            <p:spPr>
              <a:xfrm>
                <a:off x="900360" y="6127920"/>
                <a:ext cx="152280" cy="380880"/>
              </a:xfrm>
              <a:prstGeom prst="rect">
                <a:avLst/>
              </a:prstGeom>
              <a:noFill/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900360" y="5397480"/>
                <a:ext cx="152280" cy="381240"/>
              </a:xfrm>
              <a:prstGeom prst="rect">
                <a:avLst/>
              </a:prstGeom>
              <a:noFill/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2855880" y="5410440"/>
                <a:ext cx="152640" cy="380880"/>
              </a:xfrm>
              <a:prstGeom prst="rect">
                <a:avLst/>
              </a:prstGeom>
              <a:noFill/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5167440" y="5079960"/>
                <a:ext cx="152280" cy="381240"/>
              </a:xfrm>
              <a:prstGeom prst="rect">
                <a:avLst/>
              </a:prstGeom>
              <a:noFill/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5383440" y="5086440"/>
                <a:ext cx="152280" cy="380880"/>
              </a:xfrm>
              <a:prstGeom prst="rect">
                <a:avLst/>
              </a:prstGeom>
              <a:noFill/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5605560" y="5086440"/>
                <a:ext cx="152280" cy="380880"/>
              </a:xfrm>
              <a:prstGeom prst="rect">
                <a:avLst/>
              </a:prstGeom>
              <a:noFill/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5821560" y="5086440"/>
                <a:ext cx="152280" cy="380880"/>
              </a:xfrm>
              <a:prstGeom prst="rect">
                <a:avLst/>
              </a:prstGeom>
              <a:noFill/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6043680" y="5086440"/>
                <a:ext cx="152280" cy="380880"/>
              </a:xfrm>
              <a:prstGeom prst="rect">
                <a:avLst/>
              </a:prstGeom>
              <a:noFill/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5008680" y="2800440"/>
                <a:ext cx="152280" cy="380880"/>
              </a:xfrm>
              <a:prstGeom prst="rect">
                <a:avLst/>
              </a:prstGeom>
              <a:noFill/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5789520" y="2584440"/>
                <a:ext cx="152640" cy="381240"/>
              </a:xfrm>
              <a:prstGeom prst="rect">
                <a:avLst/>
              </a:prstGeom>
              <a:noFill/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2195640" y="3276720"/>
                <a:ext cx="152280" cy="380880"/>
              </a:xfrm>
              <a:prstGeom prst="rect">
                <a:avLst/>
              </a:prstGeom>
              <a:noFill/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1674720" y="2635200"/>
                <a:ext cx="152640" cy="381240"/>
              </a:xfrm>
              <a:prstGeom prst="rect">
                <a:avLst/>
              </a:prstGeom>
              <a:noFill/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240840" y="7739280"/>
                <a:ext cx="1904400" cy="307080"/>
              </a:xfrm>
              <a:prstGeom prst="rect">
                <a:avLst/>
              </a:prstGeom>
              <a:solidFill>
                <a:srgbClr val="bbe0e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400" spc="-1" strike="noStrike">
                    <a:solidFill>
                      <a:srgbClr val="000000"/>
                    </a:solidFill>
                    <a:latin typeface="Arial"/>
                  </a:rPr>
                  <a:t>Parkinson´s diseas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5" name=""/>
            <p:cNvSpPr/>
            <p:nvPr/>
          </p:nvSpPr>
          <p:spPr>
            <a:xfrm>
              <a:off x="2856960" y="8462880"/>
              <a:ext cx="1070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Figure 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46160" y="8204040"/>
              <a:ext cx="2314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Arial"/>
                </a:rPr>
                <a:t>(Amygdaloid proteins identifie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Arial"/>
                </a:rPr>
                <a:t>in this study, blue boxe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"/>
          <p:cNvGrpSpPr/>
          <p:nvPr/>
        </p:nvGrpSpPr>
        <p:grpSpPr>
          <a:xfrm>
            <a:off x="0" y="185400"/>
            <a:ext cx="6858000" cy="8498160"/>
            <a:chOff x="0" y="185400"/>
            <a:chExt cx="6858000" cy="8498160"/>
          </a:xfrm>
        </p:grpSpPr>
        <p:grpSp>
          <p:nvGrpSpPr>
            <p:cNvPr id="68" name=""/>
            <p:cNvGrpSpPr/>
            <p:nvPr/>
          </p:nvGrpSpPr>
          <p:grpSpPr>
            <a:xfrm>
              <a:off x="0" y="185400"/>
              <a:ext cx="6858000" cy="7824600"/>
              <a:chOff x="0" y="185400"/>
              <a:chExt cx="6858000" cy="7824600"/>
            </a:xfrm>
          </p:grpSpPr>
          <p:pic>
            <p:nvPicPr>
              <p:cNvPr id="69" name="" descr=""/>
              <p:cNvPicPr/>
              <p:nvPr/>
            </p:nvPicPr>
            <p:blipFill>
              <a:blip r:embed="rId1"/>
              <a:srcRect l="1717" t="2959" r="1931" b="3454"/>
              <a:stretch/>
            </p:blipFill>
            <p:spPr>
              <a:xfrm rot="16200000">
                <a:off x="-483120" y="668520"/>
                <a:ext cx="7824600" cy="6858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0" name=""/>
              <p:cNvSpPr/>
              <p:nvPr/>
            </p:nvSpPr>
            <p:spPr>
              <a:xfrm rot="16200000">
                <a:off x="-604080" y="6999840"/>
                <a:ext cx="1602720" cy="394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1" name=""/>
            <p:cNvSpPr/>
            <p:nvPr/>
          </p:nvSpPr>
          <p:spPr>
            <a:xfrm>
              <a:off x="2952720" y="6397560"/>
              <a:ext cx="15228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778200" y="7020000"/>
              <a:ext cx="15228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740040" y="5356080"/>
              <a:ext cx="15264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740040" y="4809960"/>
              <a:ext cx="15264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333440" y="5326200"/>
              <a:ext cx="152640" cy="36324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136520" y="5319720"/>
              <a:ext cx="15264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206880" y="4300560"/>
              <a:ext cx="15228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372280" y="4930920"/>
              <a:ext cx="152280" cy="36324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6114960" y="4275000"/>
              <a:ext cx="15264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950080" y="3430440"/>
              <a:ext cx="15228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203720" y="2452680"/>
              <a:ext cx="15228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772080" y="3611520"/>
              <a:ext cx="15228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384720" y="3247920"/>
              <a:ext cx="15228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384720" y="3763800"/>
              <a:ext cx="15228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406600" y="3247920"/>
              <a:ext cx="15228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330280" y="3745080"/>
              <a:ext cx="152640" cy="36324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101680" y="3746520"/>
              <a:ext cx="15264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860480" y="3746520"/>
              <a:ext cx="15264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638360" y="3740040"/>
              <a:ext cx="152280" cy="3636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409760" y="3745080"/>
              <a:ext cx="152280" cy="36324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40760" y="7781760"/>
              <a:ext cx="1896840" cy="307080"/>
            </a:xfrm>
            <a:prstGeom prst="rect">
              <a:avLst/>
            </a:prstGeom>
            <a:solidFill>
              <a:srgbClr val="bbe0e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Alzheimer´s diseas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750760" y="8315280"/>
              <a:ext cx="1070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Figure 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46160" y="8204040"/>
              <a:ext cx="2314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Arial"/>
                </a:rPr>
                <a:t>(Amygdaloid proteins identifie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Arial"/>
                </a:rPr>
                <a:t>in this study, blue boxe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4" name=""/>
          <p:cNvGrpSpPr/>
          <p:nvPr/>
        </p:nvGrpSpPr>
        <p:grpSpPr>
          <a:xfrm>
            <a:off x="103320" y="233280"/>
            <a:ext cx="6754680" cy="8583840"/>
            <a:chOff x="103320" y="233280"/>
            <a:chExt cx="6754680" cy="8583840"/>
          </a:xfrm>
        </p:grpSpPr>
        <p:grpSp>
          <p:nvGrpSpPr>
            <p:cNvPr id="95" name=""/>
            <p:cNvGrpSpPr/>
            <p:nvPr/>
          </p:nvGrpSpPr>
          <p:grpSpPr>
            <a:xfrm>
              <a:off x="103320" y="233280"/>
              <a:ext cx="6754680" cy="8167680"/>
              <a:chOff x="103320" y="233280"/>
              <a:chExt cx="6754680" cy="8167680"/>
            </a:xfrm>
          </p:grpSpPr>
          <p:pic>
            <p:nvPicPr>
              <p:cNvPr id="96" name="" descr=""/>
              <p:cNvPicPr/>
              <p:nvPr/>
            </p:nvPicPr>
            <p:blipFill>
              <a:blip r:embed="rId1"/>
              <a:srcRect l="2363" t="4188" r="0" b="3198"/>
              <a:stretch/>
            </p:blipFill>
            <p:spPr>
              <a:xfrm rot="16200000">
                <a:off x="-603000" y="939600"/>
                <a:ext cx="8167680" cy="6754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7" name=""/>
              <p:cNvSpPr/>
              <p:nvPr/>
            </p:nvSpPr>
            <p:spPr>
              <a:xfrm rot="16200000">
                <a:off x="-549360" y="7369560"/>
                <a:ext cx="1684440" cy="3783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8" name=""/>
            <p:cNvSpPr/>
            <p:nvPr/>
          </p:nvSpPr>
          <p:spPr>
            <a:xfrm>
              <a:off x="4789440" y="7701120"/>
              <a:ext cx="1989720" cy="307080"/>
            </a:xfrm>
            <a:prstGeom prst="rect">
              <a:avLst/>
            </a:prstGeom>
            <a:solidFill>
              <a:srgbClr val="bbe0e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Huntington´s diseas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174680" y="6051600"/>
              <a:ext cx="13356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1111320" y="6407280"/>
              <a:ext cx="13320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1108080" y="5499000"/>
              <a:ext cx="133200" cy="36216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149560" y="5689440"/>
              <a:ext cx="133200" cy="36216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270160" y="6315120"/>
              <a:ext cx="13320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3489480" y="5896080"/>
              <a:ext cx="13320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489480" y="6523200"/>
              <a:ext cx="13320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646520" y="6670800"/>
              <a:ext cx="13356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405320" y="5572080"/>
              <a:ext cx="133200" cy="36216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5103720" y="4473720"/>
              <a:ext cx="13356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4875120" y="3781440"/>
              <a:ext cx="13356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110200" y="3781440"/>
              <a:ext cx="13320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5345280" y="3781440"/>
              <a:ext cx="13320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5580000" y="3787920"/>
              <a:ext cx="13356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5808600" y="3781440"/>
              <a:ext cx="13356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6145200" y="2390760"/>
              <a:ext cx="13320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489480" y="3724200"/>
              <a:ext cx="133200" cy="36216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3489480" y="4149720"/>
              <a:ext cx="13320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3492360" y="4562640"/>
              <a:ext cx="13356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832200" y="2644920"/>
              <a:ext cx="13320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295280" y="3987720"/>
              <a:ext cx="133560" cy="36216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428840" y="3625920"/>
              <a:ext cx="13320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04920" y="3705120"/>
              <a:ext cx="133200" cy="36216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308240" y="2314440"/>
              <a:ext cx="133200" cy="36216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1879560" y="2340000"/>
              <a:ext cx="13356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2635200" y="2320920"/>
              <a:ext cx="133560" cy="36180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836440" y="8345520"/>
              <a:ext cx="1070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Figure 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399200" y="8358120"/>
              <a:ext cx="2314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Arial"/>
                </a:rPr>
                <a:t>(Amygdaloid proteins identifie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Arial"/>
                </a:rPr>
                <a:t>in this study, blue boxe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2257560" y="1962000"/>
              <a:ext cx="133200" cy="362160"/>
            </a:xfrm>
            <a:prstGeom prst="rect">
              <a:avLst/>
            </a:prstGeom>
            <a:noFill/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Enrique</cp:lastModifiedBy>
  <dcterms:modified xsi:type="dcterms:W3CDTF">2013-09-20T14:57:04Z</dcterms:modified>
  <cp:revision>3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  <property fmtid="{D5CDD505-2E9C-101B-9397-08002B2CF9AE}" pid="6" name="Version">
    <vt:r8>1</vt:r8>
  </property>
</Properties>
</file>